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4C3C72ED-58BD-4395-92F2-919FA2D478EF}">
          <p14:sldIdLst>
            <p14:sldId id="310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80" autoAdjust="0"/>
    <p:restoredTop sz="96727" autoAdjust="0"/>
  </p:normalViewPr>
  <p:slideViewPr>
    <p:cSldViewPr snapToGrid="0">
      <p:cViewPr varScale="1">
        <p:scale>
          <a:sx n="86" d="100"/>
          <a:sy n="86" d="100"/>
        </p:scale>
        <p:origin x="287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CD2233-616B-40A3-929C-AA85A602DE5C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A64D55-A388-4C65-A67B-F375110519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82811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Figure S2</a:t>
            </a:r>
            <a:endParaRPr lang="zh-CN" altLang="en-US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3A64D55-A388-4C65-A67B-F3751105195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47234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3936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4522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6857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8244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9889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6836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5876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2965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7087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2781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9978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750EE-7704-498B-B930-E3105E69F080}" type="datetimeFigureOut">
              <a:rPr lang="zh-CN" altLang="en-US" smtClean="0"/>
              <a:t>2022/6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2456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E3C94B75-5E5E-4A90-AE65-5B5784729CF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50445" y="1787511"/>
          <a:ext cx="1670853" cy="1317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4139400" imgH="3265877" progId="Prism8.Document">
                  <p:embed/>
                </p:oleObj>
              </mc:Choice>
              <mc:Fallback>
                <p:oleObj name="Prism 8" r:id="rId3" imgW="4139400" imgH="3265877" progId="Prism8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E3C94B75-5E5E-4A90-AE65-5B5784729CF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50445" y="1787511"/>
                        <a:ext cx="1670853" cy="1317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对象 23">
            <a:extLst>
              <a:ext uri="{FF2B5EF4-FFF2-40B4-BE49-F238E27FC236}">
                <a16:creationId xmlns:a16="http://schemas.microsoft.com/office/drawing/2014/main" id="{D9510094-0AEE-4906-8A70-CAE102413B8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66738" y="296863"/>
          <a:ext cx="1565275" cy="1235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4139400" imgH="3265877" progId="Prism8.Document">
                  <p:embed/>
                </p:oleObj>
              </mc:Choice>
              <mc:Fallback>
                <p:oleObj name="Prism 8" r:id="rId5" imgW="4139400" imgH="3265877" progId="Prism8.Document">
                  <p:embed/>
                  <p:pic>
                    <p:nvPicPr>
                      <p:cNvPr id="24" name="对象 23">
                        <a:extLst>
                          <a:ext uri="{FF2B5EF4-FFF2-40B4-BE49-F238E27FC236}">
                            <a16:creationId xmlns:a16="http://schemas.microsoft.com/office/drawing/2014/main" id="{D9510094-0AEE-4906-8A70-CAE102413B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66738" y="296863"/>
                        <a:ext cx="1565275" cy="1235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对象 24">
            <a:extLst>
              <a:ext uri="{FF2B5EF4-FFF2-40B4-BE49-F238E27FC236}">
                <a16:creationId xmlns:a16="http://schemas.microsoft.com/office/drawing/2014/main" id="{0617F92E-2D34-4010-AFBA-43B75D255AD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032000" y="284163"/>
          <a:ext cx="1619250" cy="1273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4139400" imgH="3256513" progId="Prism8.Document">
                  <p:embed/>
                </p:oleObj>
              </mc:Choice>
              <mc:Fallback>
                <p:oleObj name="Prism 8" r:id="rId7" imgW="4139400" imgH="3256513" progId="Prism8.Document">
                  <p:embed/>
                  <p:pic>
                    <p:nvPicPr>
                      <p:cNvPr id="25" name="对象 24">
                        <a:extLst>
                          <a:ext uri="{FF2B5EF4-FFF2-40B4-BE49-F238E27FC236}">
                            <a16:creationId xmlns:a16="http://schemas.microsoft.com/office/drawing/2014/main" id="{0617F92E-2D34-4010-AFBA-43B75D255AD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032000" y="284163"/>
                        <a:ext cx="1619250" cy="1273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对象 25">
            <a:extLst>
              <a:ext uri="{FF2B5EF4-FFF2-40B4-BE49-F238E27FC236}">
                <a16:creationId xmlns:a16="http://schemas.microsoft.com/office/drawing/2014/main" id="{A403CF1C-2761-4293-B0CF-22DE5889F65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48063" y="304700"/>
          <a:ext cx="1567614" cy="1238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4139400" imgH="3265877" progId="Prism8.Document">
                  <p:embed/>
                </p:oleObj>
              </mc:Choice>
              <mc:Fallback>
                <p:oleObj name="Prism 8" r:id="rId9" imgW="4139400" imgH="3265877" progId="Prism8.Document">
                  <p:embed/>
                  <p:pic>
                    <p:nvPicPr>
                      <p:cNvPr id="26" name="对象 25">
                        <a:extLst>
                          <a:ext uri="{FF2B5EF4-FFF2-40B4-BE49-F238E27FC236}">
                            <a16:creationId xmlns:a16="http://schemas.microsoft.com/office/drawing/2014/main" id="{A403CF1C-2761-4293-B0CF-22DE5889F65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48063" y="304700"/>
                        <a:ext cx="1567614" cy="1238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对象 26">
            <a:extLst>
              <a:ext uri="{FF2B5EF4-FFF2-40B4-BE49-F238E27FC236}">
                <a16:creationId xmlns:a16="http://schemas.microsoft.com/office/drawing/2014/main" id="{368F7054-E814-42DA-9ADA-14C6F8B8EC6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108678" y="3394115"/>
          <a:ext cx="1680177" cy="13256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4139400" imgH="3265877" progId="Prism8.Document">
                  <p:embed/>
                </p:oleObj>
              </mc:Choice>
              <mc:Fallback>
                <p:oleObj name="Prism 8" r:id="rId11" imgW="4139400" imgH="3265877" progId="Prism8.Document">
                  <p:embed/>
                  <p:pic>
                    <p:nvPicPr>
                      <p:cNvPr id="27" name="对象 26">
                        <a:extLst>
                          <a:ext uri="{FF2B5EF4-FFF2-40B4-BE49-F238E27FC236}">
                            <a16:creationId xmlns:a16="http://schemas.microsoft.com/office/drawing/2014/main" id="{368F7054-E814-42DA-9ADA-14C6F8B8EC6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108678" y="3394115"/>
                        <a:ext cx="1680177" cy="13256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对象 27">
            <a:extLst>
              <a:ext uri="{FF2B5EF4-FFF2-40B4-BE49-F238E27FC236}">
                <a16:creationId xmlns:a16="http://schemas.microsoft.com/office/drawing/2014/main" id="{193CE5FD-FC13-4CF9-96E3-2323067819D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879975" y="304700"/>
          <a:ext cx="1593131" cy="1252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3" imgW="4139400" imgH="3256513" progId="Prism8.Document">
                  <p:embed/>
                </p:oleObj>
              </mc:Choice>
              <mc:Fallback>
                <p:oleObj name="Prism 8" r:id="rId13" imgW="4139400" imgH="3256513" progId="Prism8.Document">
                  <p:embed/>
                  <p:pic>
                    <p:nvPicPr>
                      <p:cNvPr id="28" name="对象 27">
                        <a:extLst>
                          <a:ext uri="{FF2B5EF4-FFF2-40B4-BE49-F238E27FC236}">
                            <a16:creationId xmlns:a16="http://schemas.microsoft.com/office/drawing/2014/main" id="{193CE5FD-FC13-4CF9-96E3-2323067819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879975" y="304700"/>
                        <a:ext cx="1593131" cy="1252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对象 28">
            <a:extLst>
              <a:ext uri="{FF2B5EF4-FFF2-40B4-BE49-F238E27FC236}">
                <a16:creationId xmlns:a16="http://schemas.microsoft.com/office/drawing/2014/main" id="{DA0AF848-9E15-482A-8941-3BE7EAFC035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576256" y="3408333"/>
          <a:ext cx="1645042" cy="12972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5" imgW="4139400" imgH="3265877" progId="Prism8.Document">
                  <p:embed/>
                </p:oleObj>
              </mc:Choice>
              <mc:Fallback>
                <p:oleObj name="Prism 8" r:id="rId15" imgW="4139400" imgH="3265877" progId="Prism8.Document">
                  <p:embed/>
                  <p:pic>
                    <p:nvPicPr>
                      <p:cNvPr id="29" name="对象 28">
                        <a:extLst>
                          <a:ext uri="{FF2B5EF4-FFF2-40B4-BE49-F238E27FC236}">
                            <a16:creationId xmlns:a16="http://schemas.microsoft.com/office/drawing/2014/main" id="{DA0AF848-9E15-482A-8941-3BE7EAFC035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576256" y="3408333"/>
                        <a:ext cx="1645042" cy="12972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对象 29">
            <a:extLst>
              <a:ext uri="{FF2B5EF4-FFF2-40B4-BE49-F238E27FC236}">
                <a16:creationId xmlns:a16="http://schemas.microsoft.com/office/drawing/2014/main" id="{EA24D5B0-7CE3-4137-8A2D-EE00F8FC1FA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032000" y="1787511"/>
          <a:ext cx="1704975" cy="1344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7" imgW="4139400" imgH="3265877" progId="Prism8.Document">
                  <p:embed/>
                </p:oleObj>
              </mc:Choice>
              <mc:Fallback>
                <p:oleObj name="Prism 8" r:id="rId17" imgW="4139400" imgH="3265877" progId="Prism8.Document">
                  <p:embed/>
                  <p:pic>
                    <p:nvPicPr>
                      <p:cNvPr id="30" name="对象 29">
                        <a:extLst>
                          <a:ext uri="{FF2B5EF4-FFF2-40B4-BE49-F238E27FC236}">
                            <a16:creationId xmlns:a16="http://schemas.microsoft.com/office/drawing/2014/main" id="{EA24D5B0-7CE3-4137-8A2D-EE00F8FC1F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032000" y="1787511"/>
                        <a:ext cx="1704975" cy="1344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对象 30">
            <a:extLst>
              <a:ext uri="{FF2B5EF4-FFF2-40B4-BE49-F238E27FC236}">
                <a16:creationId xmlns:a16="http://schemas.microsoft.com/office/drawing/2014/main" id="{5A87D4FB-3C8F-4484-901A-8A4E63FFB14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973637" y="1779573"/>
          <a:ext cx="1704975" cy="1343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9" imgW="4139400" imgH="3265877" progId="Prism8.Document">
                  <p:embed/>
                </p:oleObj>
              </mc:Choice>
              <mc:Fallback>
                <p:oleObj name="Prism 8" r:id="rId19" imgW="4139400" imgH="3265877" progId="Prism8.Document">
                  <p:embed/>
                  <p:pic>
                    <p:nvPicPr>
                      <p:cNvPr id="31" name="对象 30">
                        <a:extLst>
                          <a:ext uri="{FF2B5EF4-FFF2-40B4-BE49-F238E27FC236}">
                            <a16:creationId xmlns:a16="http://schemas.microsoft.com/office/drawing/2014/main" id="{5A87D4FB-3C8F-4484-901A-8A4E63FFB14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973637" y="1779573"/>
                        <a:ext cx="1704975" cy="1343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对象 31">
            <a:extLst>
              <a:ext uri="{FF2B5EF4-FFF2-40B4-BE49-F238E27FC236}">
                <a16:creationId xmlns:a16="http://schemas.microsoft.com/office/drawing/2014/main" id="{4139524B-80BD-455A-B46C-E6E650B442C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66738" y="1808148"/>
          <a:ext cx="1684338" cy="1323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1" imgW="4139400" imgH="3256513" progId="Prism8.Document">
                  <p:embed/>
                </p:oleObj>
              </mc:Choice>
              <mc:Fallback>
                <p:oleObj name="Prism 8" r:id="rId21" imgW="4139400" imgH="3256513" progId="Prism8.Document">
                  <p:embed/>
                  <p:pic>
                    <p:nvPicPr>
                      <p:cNvPr id="32" name="对象 31">
                        <a:extLst>
                          <a:ext uri="{FF2B5EF4-FFF2-40B4-BE49-F238E27FC236}">
                            <a16:creationId xmlns:a16="http://schemas.microsoft.com/office/drawing/2014/main" id="{4139524B-80BD-455A-B46C-E6E650B442C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566738" y="1808148"/>
                        <a:ext cx="1684338" cy="1323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对象 32">
            <a:extLst>
              <a:ext uri="{FF2B5EF4-FFF2-40B4-BE49-F238E27FC236}">
                <a16:creationId xmlns:a16="http://schemas.microsoft.com/office/drawing/2014/main" id="{0555353D-4296-4676-A92D-A8098C37A55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62454" y="3373236"/>
          <a:ext cx="1735137" cy="1346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3" imgW="4139400" imgH="3210773" progId="Prism8.Document">
                  <p:embed/>
                </p:oleObj>
              </mc:Choice>
              <mc:Fallback>
                <p:oleObj name="Prism 8" r:id="rId23" imgW="4139400" imgH="3210773" progId="Prism8.Document">
                  <p:embed/>
                  <p:pic>
                    <p:nvPicPr>
                      <p:cNvPr id="33" name="对象 32">
                        <a:extLst>
                          <a:ext uri="{FF2B5EF4-FFF2-40B4-BE49-F238E27FC236}">
                            <a16:creationId xmlns:a16="http://schemas.microsoft.com/office/drawing/2014/main" id="{0555353D-4296-4676-A92D-A8098C37A55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562454" y="3373236"/>
                        <a:ext cx="1735137" cy="1346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文本框 13">
            <a:extLst>
              <a:ext uri="{FF2B5EF4-FFF2-40B4-BE49-F238E27FC236}">
                <a16:creationId xmlns:a16="http://schemas.microsoft.com/office/drawing/2014/main" id="{EDFB1155-B10C-491A-BC26-9830A07F13B5}"/>
              </a:ext>
            </a:extLst>
          </p:cNvPr>
          <p:cNvSpPr txBox="1"/>
          <p:nvPr/>
        </p:nvSpPr>
        <p:spPr>
          <a:xfrm>
            <a:off x="743139" y="1463565"/>
            <a:ext cx="13821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d (18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GAGCTGCCCAAATGAA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d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GGAGCTGCCCAAATGAA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d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GGGAGCTGCCCAAATGAA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d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GGGGAGCTGCCCAAATGAA</a:t>
            </a:r>
            <a:endParaRPr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087AAC9-BFEE-441E-B3D2-882F172D61F7}"/>
              </a:ext>
            </a:extLst>
          </p:cNvPr>
          <p:cNvSpPr txBox="1"/>
          <p:nvPr/>
        </p:nvSpPr>
        <p:spPr>
          <a:xfrm>
            <a:off x="3769747" y="1451623"/>
            <a:ext cx="1512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1 (18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TGGTTAGGCTAGGGCTT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1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TTGGTTAGGCTAGGGCTT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1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TTTGGTTAGGCTAGGGCTT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1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GGGGAGCTGCCCAAATGAA</a:t>
            </a:r>
            <a:endParaRPr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E45B80F-4332-4E05-B516-588AFA759287}"/>
              </a:ext>
            </a:extLst>
          </p:cNvPr>
          <p:cNvSpPr txBox="1"/>
          <p:nvPr/>
        </p:nvSpPr>
        <p:spPr>
          <a:xfrm>
            <a:off x="2244160" y="1463544"/>
            <a:ext cx="13115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PD1 (18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TTCCAGGGCCTGTCTG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PD1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GTTCCAGGGCCTGTCTG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PD1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GGTTCCAGGGCCTGTCTG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PD1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GGGTTCCAGGGCCTGTCTG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8A33C2A-C621-4C70-8E4F-9B88771C958D}"/>
              </a:ext>
            </a:extLst>
          </p:cNvPr>
          <p:cNvSpPr txBox="1"/>
          <p:nvPr/>
        </p:nvSpPr>
        <p:spPr>
          <a:xfrm>
            <a:off x="5118100" y="1454769"/>
            <a:ext cx="13388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TRAC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18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GGAAGAAGGTGTCTTC</a:t>
            </a:r>
          </a:p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TRAC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GGGAAGAAGGTGTCTT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TRAC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TGGGGAAGAAGGTGTCTT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TRAC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CTGGGGAAGAAGGTGTCTTC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D8501DB-87D8-4014-AD3C-A8A462F6D8A2}"/>
              </a:ext>
            </a:extLst>
          </p:cNvPr>
          <p:cNvSpPr txBox="1"/>
          <p:nvPr/>
        </p:nvSpPr>
        <p:spPr>
          <a:xfrm>
            <a:off x="2267508" y="3049272"/>
            <a:ext cx="13067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2 (18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GCCCAAGATAGTTAAG</a:t>
            </a:r>
            <a:endParaRPr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2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CAGCCCAAGATAGTTAAG</a:t>
            </a:r>
            <a:endParaRPr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2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CAGCCCAAGATAGTTAAG</a:t>
            </a:r>
            <a:endParaRPr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2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CACAGCCCAAGATAGTTAAG</a:t>
            </a:r>
            <a:endParaRPr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60AF894-044F-4F13-92F0-79625A587B92}"/>
              </a:ext>
            </a:extLst>
          </p:cNvPr>
          <p:cNvSpPr txBox="1"/>
          <p:nvPr/>
        </p:nvSpPr>
        <p:spPr>
          <a:xfrm>
            <a:off x="782201" y="3045654"/>
            <a:ext cx="13276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CR5 (18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TGTTTGCGTCTCTCC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CR5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TGTGTTTGCGTCTCTCC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CR5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CTGTGTTTGCGTCTCTCCC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CR5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CTGTGTTTGCGTCTCTCCC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5A44FE5-3263-45FE-A5A5-9200860EC0FE}"/>
              </a:ext>
            </a:extLst>
          </p:cNvPr>
          <p:cNvSpPr txBox="1"/>
          <p:nvPr/>
        </p:nvSpPr>
        <p:spPr>
          <a:xfrm>
            <a:off x="5255420" y="3042302"/>
            <a:ext cx="14565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CIITA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18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TCTCTGAGGCTGGAA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CIITA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ATCTCTGAGGCTGGAA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CIITA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AATCTCTGAGGCTGGAA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sgCIITA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CAAATCTCTGAGGCTGGAAC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44120278-0AA8-444D-9F81-D32292CBFCF5}"/>
              </a:ext>
            </a:extLst>
          </p:cNvPr>
          <p:cNvSpPr txBox="1"/>
          <p:nvPr/>
        </p:nvSpPr>
        <p:spPr>
          <a:xfrm>
            <a:off x="3793139" y="3042841"/>
            <a:ext cx="1388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c (18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GAGAGCAAGGGGAAGA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c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CAGAGAGCAAGGGGAAGA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c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CAGAGAGCAAGGGGAAGA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AVS1c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AGCAGAGAGCAAGGGGAAGA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E093908-32E5-426F-9A2E-B248F8D61968}"/>
              </a:ext>
            </a:extLst>
          </p:cNvPr>
          <p:cNvSpPr txBox="1"/>
          <p:nvPr/>
        </p:nvSpPr>
        <p:spPr>
          <a:xfrm>
            <a:off x="839451" y="4659334"/>
            <a:ext cx="13548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D326 (18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TGGTGTGTGAACACTG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D326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CTGGTGTGTGAACACTGC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D326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CTGGTGTGTGAACACTG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CD326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TGCTGGTGTGTGAACACTGC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8194FD90-E4D4-42FF-8722-84E4C52EFD7C}"/>
              </a:ext>
            </a:extLst>
          </p:cNvPr>
          <p:cNvSpPr txBox="1"/>
          <p:nvPr/>
        </p:nvSpPr>
        <p:spPr>
          <a:xfrm>
            <a:off x="2312278" y="4654680"/>
            <a:ext cx="13340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2 (18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CTTTGTACATGTGGGAC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2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GCTTTGTACATGTGGGAC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2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GCTTTGTACATGTGGGAC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ALB-2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AGGCTTTGTACATGTGGGAC</a:t>
            </a: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93A7483D-658C-4A4B-9854-15E5D58500DD}"/>
              </a:ext>
            </a:extLst>
          </p:cNvPr>
          <p:cNvSpPr txBox="1"/>
          <p:nvPr/>
        </p:nvSpPr>
        <p:spPr>
          <a:xfrm>
            <a:off x="3789617" y="4637194"/>
            <a:ext cx="13035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1 (18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GAATCTTTGGAGTACCTG</a:t>
            </a: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1 (19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GAATCTTTGGAGTACCTG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1 (20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TGAATCTTTGGAGTACCTG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sgB2M1 (21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r>
              <a:rPr kumimoji="1" lang="en-US" altLang="zh-CN" sz="400" dirty="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kumimoji="1" lang="en-US" altLang="zh-CN" sz="400" dirty="0" err="1">
                <a:latin typeface="Arial" panose="020B0604020202020204" pitchFamily="34" charset="0"/>
                <a:cs typeface="Arial" panose="020B0604020202020204" pitchFamily="34" charset="0"/>
              </a:rPr>
              <a:t>gCTGAATCTTTGGAGTACCTG</a:t>
            </a:r>
            <a:endParaRPr kumimoji="1" lang="en-US" altLang="zh-CN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8229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8</TotalTime>
  <Words>267</Words>
  <Application>Microsoft Office PowerPoint</Application>
  <PresentationFormat>A4 纸张(210x297 毫米)</PresentationFormat>
  <Paragraphs>46</Paragraphs>
  <Slides>1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Office 主题​​</vt:lpstr>
      <vt:lpstr>Prism 8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xue Yang</dc:creator>
  <cp:lastModifiedBy>Zhixue Yang</cp:lastModifiedBy>
  <cp:revision>13</cp:revision>
  <dcterms:created xsi:type="dcterms:W3CDTF">2021-10-03T13:46:32Z</dcterms:created>
  <dcterms:modified xsi:type="dcterms:W3CDTF">2022-06-06T13:27:48Z</dcterms:modified>
</cp:coreProperties>
</file>